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1655B-BD60-46AD-BBFC-3ACDD7C0C308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757F-9CAA-4E74-9524-69B797B83A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89616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1655B-BD60-46AD-BBFC-3ACDD7C0C308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757F-9CAA-4E74-9524-69B797B83A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47929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1655B-BD60-46AD-BBFC-3ACDD7C0C308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757F-9CAA-4E74-9524-69B797B83A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954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1655B-BD60-46AD-BBFC-3ACDD7C0C308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757F-9CAA-4E74-9524-69B797B83A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64644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1655B-BD60-46AD-BBFC-3ACDD7C0C308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757F-9CAA-4E74-9524-69B797B83A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391957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1655B-BD60-46AD-BBFC-3ACDD7C0C308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757F-9CAA-4E74-9524-69B797B83A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62670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1655B-BD60-46AD-BBFC-3ACDD7C0C308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757F-9CAA-4E74-9524-69B797B83A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55286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1655B-BD60-46AD-BBFC-3ACDD7C0C308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757F-9CAA-4E74-9524-69B797B83A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47886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1655B-BD60-46AD-BBFC-3ACDD7C0C308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757F-9CAA-4E74-9524-69B797B83A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94911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1655B-BD60-46AD-BBFC-3ACDD7C0C308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757F-9CAA-4E74-9524-69B797B83A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3043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81655B-BD60-46AD-BBFC-3ACDD7C0C308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757F-9CAA-4E74-9524-69B797B83A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691026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81655B-BD60-46AD-BBFC-3ACDD7C0C308}" type="datetimeFigureOut">
              <a:rPr lang="de-DE" smtClean="0"/>
              <a:t>04.02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2B757F-9CAA-4E74-9524-69B797B83AA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848908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6"/>
          <p:cNvSpPr txBox="1">
            <a:spLocks noChangeArrowheads="1"/>
          </p:cNvSpPr>
          <p:nvPr/>
        </p:nvSpPr>
        <p:spPr bwMode="auto">
          <a:xfrm>
            <a:off x="169831" y="26752"/>
            <a:ext cx="2943434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de-CH" altLang="de-DE" sz="3000" b="1" i="1" dirty="0" smtClean="0"/>
              <a:t>SupFigure S1A</a:t>
            </a:r>
            <a:endParaRPr lang="en-GB" altLang="de-DE" sz="3000" b="1" i="1" dirty="0"/>
          </a:p>
        </p:txBody>
      </p:sp>
      <p:sp>
        <p:nvSpPr>
          <p:cNvPr id="6" name="Rechteck 5"/>
          <p:cNvSpPr/>
          <p:nvPr/>
        </p:nvSpPr>
        <p:spPr>
          <a:xfrm>
            <a:off x="325315" y="942554"/>
            <a:ext cx="4360985" cy="37856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800" b="0" i="0" u="none" strike="noStrike" dirty="0" err="1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uta-Ag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1  ------------------------------</a:t>
            </a:r>
            <a:r>
              <a:rPr lang="de-DE" sz="800" b="0" i="0" u="none" strike="noStrike" dirty="0" smtClean="0"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CC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de-DE" sz="800" b="0" i="0" u="none" strike="noStrike" dirty="0" smtClean="0"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LNKQMGKRNTILLCGP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19</a:t>
            </a:r>
          </a:p>
          <a:p>
            <a:r>
              <a:rPr lang="de-DE" sz="800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800" dirty="0" smtClean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	</a:t>
            </a:r>
            <a:r>
              <a:rPr lang="de-DE" sz="800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de-DE" sz="800" dirty="0" smtClean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:|| ||:|.|||||:|..|| </a:t>
            </a:r>
          </a:p>
          <a:p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H1-PV 351  SKLANFS</a:t>
            </a:r>
            <a:r>
              <a:rPr lang="de-DE" sz="800" b="0" i="0" u="none" strike="noStrike" dirty="0" smtClean="0">
                <a:solidFill>
                  <a:srgbClr val="00B05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ASTRTCRIFAEHGWNYIKVCHAICCVLNRQGGKRNTVLFHGP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400 </a:t>
            </a:r>
          </a:p>
          <a:p>
            <a:endParaRPr lang="de-DE" sz="800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800" b="0" i="0" u="none" strike="noStrike" dirty="0" err="1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uta-Ag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20 </a:t>
            </a:r>
            <a:r>
              <a:rPr lang="de-DE" sz="800" b="0" i="0" u="none" strike="noStrike" dirty="0" smtClean="0"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STGKSLISQTIANLVGNVGCYNPSNANFPFNDCSNKNLIWIEEAGNFGT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69 </a:t>
            </a:r>
          </a:p>
          <a:p>
            <a:r>
              <a:rPr lang="de-DE" sz="800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de-DE" sz="800" dirty="0" smtClean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||||||:|:|.||..||||||||.:|.|||||||:||||||:|||||||. </a:t>
            </a:r>
          </a:p>
          <a:p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H1-PV  401 </a:t>
            </a:r>
            <a:r>
              <a:rPr lang="de-DE" sz="800" b="0" i="0" u="none" strike="noStrike" dirty="0" smtClean="0">
                <a:solidFill>
                  <a:srgbClr val="00B05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STGKSIIAQAIAQAVGNVGCYNAANVNFPFNDCTNKNLIWVEEAGNFGQ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450 </a:t>
            </a:r>
          </a:p>
          <a:p>
            <a:endParaRPr lang="de-DE" sz="800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800" b="0" i="0" u="none" strike="noStrike" dirty="0" err="1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uta-Ag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70 </a:t>
            </a:r>
            <a:r>
              <a:rPr lang="de-DE" sz="800" b="0" i="0" u="none" strike="noStrike" dirty="0" smtClean="0"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QVNSFKAIMSGQAIRLDQKGKGSKQIEPTPVIMTTNEDITKVIVGTELKT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119</a:t>
            </a:r>
          </a:p>
          <a:p>
            <a:r>
              <a:rPr lang="de-DE" sz="800" dirty="0" smtClean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|||.||||.|||.||:|||||||||||||||||||||:||.|.:|.|.:. </a:t>
            </a:r>
          </a:p>
          <a:p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H1-PV  451 </a:t>
            </a:r>
            <a:r>
              <a:rPr lang="de-DE" sz="800" b="0" i="0" u="none" strike="noStrike" dirty="0" smtClean="0">
                <a:solidFill>
                  <a:srgbClr val="00B05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QVNQFKAICSGQTIRIDQKGKGSKQIEPTPVIMTTN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ENITVVRIGCEERP 500 </a:t>
            </a:r>
          </a:p>
          <a:p>
            <a:endParaRPr lang="de-DE" sz="800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800" b="0" i="0" u="none" strike="noStrike" dirty="0" err="1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uta-Ag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120 </a:t>
            </a:r>
            <a:r>
              <a:rPr lang="de-DE" sz="800" b="0" i="0" u="none" strike="noStrike" dirty="0" smtClean="0"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EHRQPIMDRCLRIELKHKLPGDHGLLHNYEIPTIFKYLELHGFYPTMKSY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169 </a:t>
            </a:r>
          </a:p>
          <a:p>
            <a:r>
              <a:rPr lang="de-DE" sz="800" dirty="0" smtClean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||.|||.||.|.|.|...||||.||:..:|.|.|..:|..:|:..||..| </a:t>
            </a:r>
          </a:p>
          <a:p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H1-PV   501 EHTQPIRDRMLNIHLTRTLPGDFGLVDKHEWPLICAWLVKNGYQST</a:t>
            </a:r>
            <a:r>
              <a:rPr lang="de-DE" sz="800" b="0" i="0" u="none" strike="noStrike" dirty="0" smtClean="0">
                <a:solidFill>
                  <a:srgbClr val="00B05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ACY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550 </a:t>
            </a:r>
          </a:p>
          <a:p>
            <a:endParaRPr lang="de-DE" sz="800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800" b="0" i="0" u="none" strike="noStrike" dirty="0" err="1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uta-Ag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170 </a:t>
            </a:r>
            <a:r>
              <a:rPr lang="de-DE" sz="800" b="0" i="0" u="none" strike="noStrike" dirty="0" smtClean="0"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IERWETTPTWGENWNTKAKEATSHLPDEEREDEEHTPPNSPIPTTQQQSL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219 </a:t>
            </a:r>
          </a:p>
          <a:p>
            <a:r>
              <a:rPr lang="de-DE" sz="800" dirty="0" smtClean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..:|...|.|.|:|               .|.:..||.|| :.:.:..|| </a:t>
            </a:r>
          </a:p>
          <a:p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H1-PV   551 </a:t>
            </a:r>
            <a:r>
              <a:rPr lang="de-DE" sz="800" b="0" i="0" u="none" strike="noStrike" dirty="0" smtClean="0">
                <a:solidFill>
                  <a:srgbClr val="00B05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AKWGKVPDWSEDW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-----------</a:t>
            </a:r>
            <a:r>
              <a:rPr lang="de-DE" sz="800" b="0" i="0" u="none" strike="noStrike" dirty="0" smtClean="0">
                <a:solidFill>
                  <a:srgbClr val="00B05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EPKLDTPINS-LGSMRSPSL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584 </a:t>
            </a:r>
          </a:p>
          <a:p>
            <a:endParaRPr lang="de-DE" sz="800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800" b="0" i="0" u="none" strike="noStrike" dirty="0" err="1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uta-Ag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220 </a:t>
            </a:r>
            <a:r>
              <a:rPr lang="de-DE" sz="800" b="0" i="0" u="none" strike="noStrike" dirty="0" smtClean="0"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ESLDPDDQEFAM--LLKDIEETERALQTIPEEEPNTEELAATGYGQPLI 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267 </a:t>
            </a:r>
          </a:p>
          <a:p>
            <a:r>
              <a:rPr lang="de-DE" sz="800" dirty="0" smtClean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.....|..|.:|:  |..|: .:.||:   |...|||.           : </a:t>
            </a:r>
          </a:p>
          <a:p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H1-PV   585 </a:t>
            </a:r>
            <a:r>
              <a:rPr lang="de-DE" sz="800" b="0" i="0" u="none" strike="noStrike" dirty="0" smtClean="0">
                <a:solidFill>
                  <a:srgbClr val="00B05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PRSTPLSQNYALTPLASDL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lang="de-DE" sz="800" b="0" i="0" u="none" strike="noStrike" dirty="0" smtClean="0">
                <a:solidFill>
                  <a:srgbClr val="00B05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DLALE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</a:t>
            </a:r>
            <a:r>
              <a:rPr lang="de-DE" sz="800" b="0" i="0" u="none" strike="noStrike" dirty="0" smtClean="0">
                <a:solidFill>
                  <a:srgbClr val="00B05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WSTPNTP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-------</a:t>
            </a:r>
            <a:r>
              <a:rPr lang="de-DE" sz="800" b="0" i="0" u="none" strike="noStrike" dirty="0" smtClean="0">
                <a:solidFill>
                  <a:srgbClr val="00B05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V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619 </a:t>
            </a:r>
          </a:p>
          <a:p>
            <a:endParaRPr lang="de-DE" sz="800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800" b="0" i="0" u="none" strike="noStrike" dirty="0" err="1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uta-Ag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268 </a:t>
            </a:r>
            <a:r>
              <a:rPr lang="de-DE" sz="800" b="0" i="0" u="none" strike="noStrike" dirty="0" smtClean="0"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SGTDVNASY*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------------------------------------ 277 </a:t>
            </a:r>
          </a:p>
          <a:p>
            <a:r>
              <a:rPr lang="de-DE" sz="800" dirty="0" smtClean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:||..:.:.. </a:t>
            </a:r>
          </a:p>
          <a:p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H1-PV   620 </a:t>
            </a:r>
            <a:r>
              <a:rPr lang="de-DE" sz="800" b="0" i="0" u="none" strike="noStrike" dirty="0" smtClean="0">
                <a:solidFill>
                  <a:srgbClr val="00B05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GTAASQNTGEAGSTACQGAQRSPTWSEIEADLRACFSQEQLESDFNEEL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669 </a:t>
            </a:r>
          </a:p>
          <a:p>
            <a:endParaRPr lang="de-DE" sz="800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800" b="0" i="0" u="none" strike="noStrike" dirty="0" err="1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Cuta-Ag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278 ---- 277 </a:t>
            </a:r>
          </a:p>
          <a:p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H1-PV   670 </a:t>
            </a:r>
            <a:r>
              <a:rPr lang="de-DE" sz="800" b="0" i="0" u="none" strike="noStrike" dirty="0" smtClean="0">
                <a:solidFill>
                  <a:srgbClr val="00B05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TLD*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673 </a:t>
            </a:r>
            <a:endParaRPr lang="de-DE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7" name="Rechteck 6"/>
          <p:cNvSpPr/>
          <p:nvPr/>
        </p:nvSpPr>
        <p:spPr>
          <a:xfrm>
            <a:off x="5114190" y="942554"/>
            <a:ext cx="6096000" cy="1446550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B19-AgA   1 -----</a:t>
            </a:r>
            <a:r>
              <a:rPr lang="de-DE" sz="800" b="0" i="0" u="none" strike="noStrike" dirty="0" smtClean="0"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CIKDNKIVKLLLCQNYDPLLVGQHVLKWIDKKCGKKNTLWFYGP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45 	 	     ..:...:..::.....::.:.|...:...::::.||:||:.|:|| </a:t>
            </a:r>
          </a:p>
          <a:p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H1-PV   351 SKLANFS</a:t>
            </a:r>
            <a:r>
              <a:rPr lang="de-DE" sz="800" b="0" i="0" u="none" strike="noStrike" dirty="0" smtClean="0">
                <a:solidFill>
                  <a:srgbClr val="00B05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MASTRTCRIFAEHGWNYIKVCHAICCVLNRQGGKRNTVLFHGP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400 </a:t>
            </a:r>
          </a:p>
          <a:p>
            <a:endParaRPr lang="de-DE" sz="800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B19-AgA 46  </a:t>
            </a:r>
            <a:r>
              <a:rPr lang="de-DE" sz="800" b="0" i="0" u="none" strike="noStrike" dirty="0" smtClean="0"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STGKTNLAMAIAKSVPVYGMVNWNNENFPFNDVAGKSLVVWDEGIIKST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95                                     	.||||:.:|.|||::|...|..|..|.||||||...|:|:..:|...... </a:t>
            </a:r>
          </a:p>
          <a:p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H1-PV  401  </a:t>
            </a:r>
            <a:r>
              <a:rPr lang="de-DE" sz="800" b="0" i="0" u="none" strike="noStrike" dirty="0" smtClean="0">
                <a:solidFill>
                  <a:srgbClr val="00B05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STGKSIIAQAIAQAVGNVGCYNAANVNFPFNDCTNKNLIWVEEAGNFGQ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450</a:t>
            </a:r>
          </a:p>
          <a:p>
            <a:endParaRPr lang="de-DE" sz="800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B19-AgA 96  </a:t>
            </a:r>
            <a:r>
              <a:rPr lang="de-DE" sz="800" b="0" i="0" u="none" strike="noStrike" dirty="0" smtClean="0"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IVEAAKAILGGQPTRVDQKMRGSVAVPGVPVVITSNGDITFVVSG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- 140 	.|...|||..||..|:|||.:||..:...||::|:|.:||.|..| </a:t>
            </a:r>
          </a:p>
          <a:p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H1-PV   451 </a:t>
            </a:r>
            <a:r>
              <a:rPr lang="de-DE" sz="800" b="0" i="0" u="none" strike="noStrike" dirty="0" smtClean="0">
                <a:solidFill>
                  <a:srgbClr val="00B05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QVNQFKAICSGQTIRIDQKGKGSKQIEPTPVIMTTN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ENITVVRIGCEERP 500 </a:t>
            </a:r>
            <a:endParaRPr lang="de-DE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8" name="Rechteck 7"/>
          <p:cNvSpPr/>
          <p:nvPr/>
        </p:nvSpPr>
        <p:spPr>
          <a:xfrm>
            <a:off x="5114190" y="2789214"/>
            <a:ext cx="6096000" cy="193899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B19-AgB 1    ---------</a:t>
            </a:r>
            <a:r>
              <a:rPr lang="de-DE" sz="800" b="0" i="0" u="none" strike="noStrike" dirty="0" smtClean="0"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GAWNTETPRSSTPIPGTSSGESFVG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--------</a:t>
            </a:r>
            <a:r>
              <a:rPr lang="de-DE" sz="800" b="0" i="0" u="none" strike="noStrike" dirty="0" smtClean="0"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SPVS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29 </a:t>
            </a:r>
          </a:p>
          <a:p>
            <a:r>
              <a:rPr lang="de-DE" sz="800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de-DE" sz="800" dirty="0" smtClean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         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..|:|    .:||:.||::.:: .|            ||.. </a:t>
            </a:r>
          </a:p>
          <a:p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H1-PV 601    </a:t>
            </a:r>
            <a:r>
              <a:rPr lang="de-DE" sz="800" b="0" i="0" u="none" strike="noStrike" dirty="0" smtClean="0">
                <a:solidFill>
                  <a:srgbClr val="00B05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SDLADLALEPWST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</a:t>
            </a:r>
            <a:r>
              <a:rPr lang="de-DE" sz="800" b="0" i="0" u="none" strike="noStrike" dirty="0" smtClean="0">
                <a:solidFill>
                  <a:srgbClr val="00B05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PNTPVAGTAASQN-TGEAGSTACQGAQRSPTW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645 </a:t>
            </a:r>
          </a:p>
          <a:p>
            <a:endParaRPr lang="de-DE" sz="800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B19-AgB 30   </a:t>
            </a:r>
            <a:r>
              <a:rPr lang="de-DE" sz="800" b="0" i="0" u="none" strike="noStrike" dirty="0" smtClean="0"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SEVVA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-</a:t>
            </a:r>
            <a:r>
              <a:rPr lang="de-DE" sz="800" b="0" i="0" u="none" strike="noStrike" dirty="0" smtClean="0"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ASWEEAFYTPLADQFRELLVGVDYVWDGVRGLPVCCVQHI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74 </a:t>
            </a:r>
          </a:p>
          <a:p>
            <a:r>
              <a:rPr lang="de-DE" sz="800" dirty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r>
              <a:rPr lang="de-DE" sz="800" dirty="0" smtClean="0">
                <a:solidFill>
                  <a:srgbClr val="222222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            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||:.|     .|.|:     |...|.|.|. :|. </a:t>
            </a:r>
          </a:p>
          <a:p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H1-PV  646   </a:t>
            </a:r>
            <a:r>
              <a:rPr lang="de-DE" sz="800" b="0" i="0" u="none" strike="noStrike" dirty="0" smtClean="0">
                <a:solidFill>
                  <a:srgbClr val="00B05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SEIEADLRACFSQEQ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----</a:t>
            </a:r>
            <a:r>
              <a:rPr lang="de-DE" sz="800" b="0" i="0" u="none" strike="noStrike" dirty="0" smtClean="0">
                <a:solidFill>
                  <a:srgbClr val="00B05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LESDFNEELT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-</a:t>
            </a:r>
            <a:r>
              <a:rPr lang="de-DE" sz="800" b="0" i="0" u="none" strike="noStrike" dirty="0" smtClean="0">
                <a:solidFill>
                  <a:srgbClr val="00B05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LD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*---------------- 673 </a:t>
            </a:r>
          </a:p>
          <a:p>
            <a:endParaRPr lang="de-DE" sz="800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B19-AgB 75   </a:t>
            </a:r>
            <a:r>
              <a:rPr lang="de-DE" sz="800" b="0" i="0" u="none" strike="noStrike" dirty="0" smtClean="0"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NNSGGGLGLCPHCINVGAWYNGWKFREFTPDLVRCSCHVGASNPFSVLTC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124 </a:t>
            </a:r>
          </a:p>
          <a:p>
            <a:endParaRPr lang="de-DE" sz="800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H1-PV  674   -------------------------------------------------- 673 </a:t>
            </a:r>
          </a:p>
          <a:p>
            <a:endParaRPr lang="de-DE" sz="800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B19-Agb 125 </a:t>
            </a:r>
            <a:r>
              <a:rPr lang="de-DE" sz="800" b="0" i="0" u="none" strike="noStrike" dirty="0" smtClean="0">
                <a:solidFill>
                  <a:srgbClr val="FF0000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KKCAYLSGLQSFVDYE*</a:t>
            </a:r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 141 </a:t>
            </a:r>
          </a:p>
          <a:p>
            <a:endParaRPr lang="de-DE" sz="800" dirty="0">
              <a:solidFill>
                <a:srgbClr val="222222"/>
              </a:solidFill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de-DE" sz="800" b="0" i="0" u="none" strike="noStrike" dirty="0" smtClean="0">
                <a:solidFill>
                  <a:srgbClr val="222222"/>
                </a:solidFill>
                <a:effectLst/>
                <a:latin typeface="Courier New" panose="02070309020205020404" pitchFamily="49" charset="0"/>
                <a:cs typeface="Courier New" panose="02070309020205020404" pitchFamily="49" charset="0"/>
              </a:rPr>
              <a:t>H1-PV   674 ----------------- 673 </a:t>
            </a:r>
            <a:endParaRPr lang="de-DE" sz="8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grpSp>
        <p:nvGrpSpPr>
          <p:cNvPr id="13" name="Gruppieren 12"/>
          <p:cNvGrpSpPr/>
          <p:nvPr/>
        </p:nvGrpSpPr>
        <p:grpSpPr>
          <a:xfrm>
            <a:off x="83975" y="5257905"/>
            <a:ext cx="10261159" cy="410547"/>
            <a:chOff x="83975" y="5257905"/>
            <a:chExt cx="10261159" cy="410547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5653" b="5706"/>
            <a:stretch/>
          </p:blipFill>
          <p:spPr>
            <a:xfrm>
              <a:off x="1809543" y="5257905"/>
              <a:ext cx="8535591" cy="410547"/>
            </a:xfrm>
            <a:prstGeom prst="rect">
              <a:avLst/>
            </a:prstGeom>
          </p:spPr>
        </p:pic>
        <p:sp>
          <p:nvSpPr>
            <p:cNvPr id="9" name="Text Box 6"/>
            <p:cNvSpPr txBox="1">
              <a:spLocks noChangeArrowheads="1"/>
            </p:cNvSpPr>
            <p:nvPr/>
          </p:nvSpPr>
          <p:spPr bwMode="auto">
            <a:xfrm>
              <a:off x="83975" y="5293901"/>
              <a:ext cx="1221809" cy="3385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de-CH" altLang="de-DE" sz="1600" b="1" dirty="0" smtClean="0"/>
                <a:t>H-1PV Heli</a:t>
              </a:r>
              <a:endParaRPr lang="en-GB" altLang="de-DE" sz="1600" b="1" dirty="0"/>
            </a:p>
          </p:txBody>
        </p:sp>
      </p:grpSp>
      <p:grpSp>
        <p:nvGrpSpPr>
          <p:cNvPr id="14" name="Gruppieren 13"/>
          <p:cNvGrpSpPr/>
          <p:nvPr/>
        </p:nvGrpSpPr>
        <p:grpSpPr>
          <a:xfrm>
            <a:off x="83975" y="5647129"/>
            <a:ext cx="10092923" cy="338554"/>
            <a:chOff x="83975" y="5641373"/>
            <a:chExt cx="10092923" cy="338554"/>
          </a:xfrm>
        </p:grpSpPr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1324"/>
            <a:stretch/>
          </p:blipFill>
          <p:spPr>
            <a:xfrm>
              <a:off x="3359538" y="5663935"/>
              <a:ext cx="6817360" cy="293431"/>
            </a:xfrm>
            <a:prstGeom prst="rect">
              <a:avLst/>
            </a:prstGeom>
          </p:spPr>
        </p:pic>
        <p:sp>
          <p:nvSpPr>
            <p:cNvPr id="10" name="Text Box 6"/>
            <p:cNvSpPr txBox="1">
              <a:spLocks noChangeArrowheads="1"/>
            </p:cNvSpPr>
            <p:nvPr/>
          </p:nvSpPr>
          <p:spPr bwMode="auto">
            <a:xfrm>
              <a:off x="83975" y="5641373"/>
              <a:ext cx="1027845" cy="3385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de-CH" altLang="de-DE" sz="1600" b="1" dirty="0" err="1" smtClean="0"/>
                <a:t>CuV</a:t>
              </a:r>
              <a:r>
                <a:rPr lang="de-CH" altLang="de-DE" sz="1600" b="1" dirty="0" smtClean="0"/>
                <a:t> Heli</a:t>
              </a:r>
              <a:endParaRPr lang="en-GB" altLang="de-DE" sz="1600" b="1" dirty="0"/>
            </a:p>
          </p:txBody>
        </p:sp>
      </p:grpSp>
      <p:grpSp>
        <p:nvGrpSpPr>
          <p:cNvPr id="15" name="Gruppieren 14"/>
          <p:cNvGrpSpPr/>
          <p:nvPr/>
        </p:nvGrpSpPr>
        <p:grpSpPr>
          <a:xfrm>
            <a:off x="83975" y="5964359"/>
            <a:ext cx="10636898" cy="446079"/>
            <a:chOff x="83975" y="5964359"/>
            <a:chExt cx="10636898" cy="446079"/>
          </a:xfrm>
        </p:grpSpPr>
        <p:pic>
          <p:nvPicPr>
            <p:cNvPr id="5" name="Grafik 4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2" t="76616"/>
            <a:stretch/>
          </p:blipFill>
          <p:spPr>
            <a:xfrm>
              <a:off x="1760220" y="5964359"/>
              <a:ext cx="8960653" cy="446079"/>
            </a:xfrm>
            <a:prstGeom prst="rect">
              <a:avLst/>
            </a:prstGeom>
          </p:spPr>
        </p:pic>
        <p:sp>
          <p:nvSpPr>
            <p:cNvPr id="11" name="Text Box 6"/>
            <p:cNvSpPr txBox="1">
              <a:spLocks noChangeArrowheads="1"/>
            </p:cNvSpPr>
            <p:nvPr/>
          </p:nvSpPr>
          <p:spPr bwMode="auto">
            <a:xfrm>
              <a:off x="83975" y="6018121"/>
              <a:ext cx="1130438" cy="33855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/>
              <a:r>
                <a:rPr lang="de-CH" altLang="de-DE" sz="1600" b="1" dirty="0" smtClean="0"/>
                <a:t>B19V Heli</a:t>
              </a:r>
              <a:endParaRPr lang="en-GB" altLang="de-DE" sz="1600" b="1" dirty="0"/>
            </a:p>
          </p:txBody>
        </p:sp>
      </p:grpSp>
      <p:sp>
        <p:nvSpPr>
          <p:cNvPr id="16" name="Text Box 6"/>
          <p:cNvSpPr txBox="1">
            <a:spLocks noChangeArrowheads="1"/>
          </p:cNvSpPr>
          <p:nvPr/>
        </p:nvSpPr>
        <p:spPr bwMode="auto">
          <a:xfrm>
            <a:off x="5114190" y="47479"/>
            <a:ext cx="2943434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de-CH" altLang="de-DE" sz="3000" b="1" i="1" dirty="0"/>
              <a:t>SupFigure S1B</a:t>
            </a:r>
            <a:endParaRPr lang="en-GB" altLang="de-DE" sz="3000" b="1" i="1" dirty="0"/>
          </a:p>
        </p:txBody>
      </p:sp>
      <p:sp>
        <p:nvSpPr>
          <p:cNvPr id="17" name="Text Box 6"/>
          <p:cNvSpPr txBox="1">
            <a:spLocks noChangeArrowheads="1"/>
          </p:cNvSpPr>
          <p:nvPr/>
        </p:nvSpPr>
        <p:spPr bwMode="auto">
          <a:xfrm>
            <a:off x="169831" y="4752053"/>
            <a:ext cx="2943434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de-CH" altLang="de-DE" sz="3000" b="1" i="1"/>
              <a:t>SupFigure S1C</a:t>
            </a:r>
            <a:endParaRPr lang="en-GB" altLang="de-DE" sz="3000" b="1" i="1" dirty="0"/>
          </a:p>
        </p:txBody>
      </p:sp>
    </p:spTree>
    <p:extLst>
      <p:ext uri="{BB962C8B-B14F-4D97-AF65-F5344CB8AC3E}">
        <p14:creationId xmlns:p14="http://schemas.microsoft.com/office/powerpoint/2010/main" val="42676734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75</Words>
  <Application>Microsoft Office PowerPoint</Application>
  <PresentationFormat>Widescreen</PresentationFormat>
  <Paragraphs>5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urier New</vt:lpstr>
      <vt:lpstr>Offic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üesch, Jürg</dc:creator>
  <cp:lastModifiedBy>MDPI</cp:lastModifiedBy>
  <cp:revision>8</cp:revision>
  <dcterms:created xsi:type="dcterms:W3CDTF">2022-01-13T12:59:31Z</dcterms:created>
  <dcterms:modified xsi:type="dcterms:W3CDTF">2022-02-04T08:38:16Z</dcterms:modified>
</cp:coreProperties>
</file>